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9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784A022-F4FC-466A-B965-DECF04915295}" v="11" dt="2021-03-26T23:20:08.7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h Hill" userId="b774f213905f0ee8" providerId="LiveId" clId="{A784A022-F4FC-466A-B965-DECF04915295}"/>
    <pc:docChg chg="undo custSel addSld delSld modSld">
      <pc:chgData name="Sarah Hill" userId="b774f213905f0ee8" providerId="LiveId" clId="{A784A022-F4FC-466A-B965-DECF04915295}" dt="2021-03-27T18:30:06.116" v="564" actId="20577"/>
      <pc:docMkLst>
        <pc:docMk/>
      </pc:docMkLst>
      <pc:sldChg chg="del">
        <pc:chgData name="Sarah Hill" userId="b774f213905f0ee8" providerId="LiveId" clId="{A784A022-F4FC-466A-B965-DECF04915295}" dt="2021-03-25T12:37:00.898" v="383" actId="2696"/>
        <pc:sldMkLst>
          <pc:docMk/>
          <pc:sldMk cId="2724142132" sldId="256"/>
        </pc:sldMkLst>
      </pc:sldChg>
      <pc:sldChg chg="addSp modSp mod">
        <pc:chgData name="Sarah Hill" userId="b774f213905f0ee8" providerId="LiveId" clId="{A784A022-F4FC-466A-B965-DECF04915295}" dt="2021-03-27T18:30:06.116" v="564" actId="20577"/>
        <pc:sldMkLst>
          <pc:docMk/>
          <pc:sldMk cId="1081373503" sldId="257"/>
        </pc:sldMkLst>
        <pc:spChg chg="mod">
          <ac:chgData name="Sarah Hill" userId="b774f213905f0ee8" providerId="LiveId" clId="{A784A022-F4FC-466A-B965-DECF04915295}" dt="2021-03-27T18:30:06.116" v="564" actId="20577"/>
          <ac:spMkLst>
            <pc:docMk/>
            <pc:sldMk cId="1081373503" sldId="257"/>
            <ac:spMk id="2" creationId="{1C27C29A-2405-449F-AA5F-D67B4EE9755F}"/>
          </ac:spMkLst>
        </pc:spChg>
        <pc:spChg chg="add mod">
          <ac:chgData name="Sarah Hill" userId="b774f213905f0ee8" providerId="LiveId" clId="{A784A022-F4FC-466A-B965-DECF04915295}" dt="2021-03-26T23:20:08.728" v="562"/>
          <ac:spMkLst>
            <pc:docMk/>
            <pc:sldMk cId="1081373503" sldId="257"/>
            <ac:spMk id="3" creationId="{2DCE6CD1-79F6-46F9-84C1-EA69A534E682}"/>
          </ac:spMkLst>
        </pc:spChg>
      </pc:sldChg>
      <pc:sldChg chg="addSp modSp new mod">
        <pc:chgData name="Sarah Hill" userId="b774f213905f0ee8" providerId="LiveId" clId="{A784A022-F4FC-466A-B965-DECF04915295}" dt="2021-03-25T12:38:39.215" v="561" actId="1038"/>
        <pc:sldMkLst>
          <pc:docMk/>
          <pc:sldMk cId="2580895711" sldId="258"/>
        </pc:sldMkLst>
        <pc:spChg chg="add mod">
          <ac:chgData name="Sarah Hill" userId="b774f213905f0ee8" providerId="LiveId" clId="{A784A022-F4FC-466A-B965-DECF04915295}" dt="2021-03-25T12:37:22.266" v="456" actId="1036"/>
          <ac:spMkLst>
            <pc:docMk/>
            <pc:sldMk cId="2580895711" sldId="258"/>
            <ac:spMk id="6" creationId="{5DA87678-9ECF-42A8-9F9B-51127A9F297C}"/>
          </ac:spMkLst>
        </pc:spChg>
        <pc:spChg chg="add mod">
          <ac:chgData name="Sarah Hill" userId="b774f213905f0ee8" providerId="LiveId" clId="{A784A022-F4FC-466A-B965-DECF04915295}" dt="2021-03-25T12:37:27.543" v="457" actId="1076"/>
          <ac:spMkLst>
            <pc:docMk/>
            <pc:sldMk cId="2580895711" sldId="258"/>
            <ac:spMk id="7" creationId="{462B11E1-2683-4C02-9FC5-ABC6519226AA}"/>
          </ac:spMkLst>
        </pc:spChg>
        <pc:spChg chg="add mod">
          <ac:chgData name="Sarah Hill" userId="b774f213905f0ee8" providerId="LiveId" clId="{A784A022-F4FC-466A-B965-DECF04915295}" dt="2021-03-25T12:37:22.266" v="456" actId="1036"/>
          <ac:spMkLst>
            <pc:docMk/>
            <pc:sldMk cId="2580895711" sldId="258"/>
            <ac:spMk id="8" creationId="{2A376A62-EDF2-4315-B22A-956B40958F81}"/>
          </ac:spMkLst>
        </pc:spChg>
        <pc:spChg chg="add mod">
          <ac:chgData name="Sarah Hill" userId="b774f213905f0ee8" providerId="LiveId" clId="{A784A022-F4FC-466A-B965-DECF04915295}" dt="2021-03-25T12:37:33.783" v="493" actId="1036"/>
          <ac:spMkLst>
            <pc:docMk/>
            <pc:sldMk cId="2580895711" sldId="258"/>
            <ac:spMk id="9" creationId="{9F4D95DE-BFF2-49B0-849C-3768E10997ED}"/>
          </ac:spMkLst>
        </pc:spChg>
        <pc:spChg chg="add mod">
          <ac:chgData name="Sarah Hill" userId="b774f213905f0ee8" providerId="LiveId" clId="{A784A022-F4FC-466A-B965-DECF04915295}" dt="2021-03-25T12:37:55.351" v="500" actId="1035"/>
          <ac:spMkLst>
            <pc:docMk/>
            <pc:sldMk cId="2580895711" sldId="258"/>
            <ac:spMk id="10" creationId="{4FA59DBF-47CA-4EED-8404-1575B22792DE}"/>
          </ac:spMkLst>
        </pc:spChg>
        <pc:spChg chg="add mod">
          <ac:chgData name="Sarah Hill" userId="b774f213905f0ee8" providerId="LiveId" clId="{A784A022-F4FC-466A-B965-DECF04915295}" dt="2021-03-25T12:38:39.215" v="561" actId="1038"/>
          <ac:spMkLst>
            <pc:docMk/>
            <pc:sldMk cId="2580895711" sldId="258"/>
            <ac:spMk id="11" creationId="{6164B682-423C-4CE0-AC9B-8790EB48CD65}"/>
          </ac:spMkLst>
        </pc:spChg>
        <pc:spChg chg="add mod">
          <ac:chgData name="Sarah Hill" userId="b774f213905f0ee8" providerId="LiveId" clId="{A784A022-F4FC-466A-B965-DECF04915295}" dt="2021-03-25T12:38:06.663" v="510" actId="1076"/>
          <ac:spMkLst>
            <pc:docMk/>
            <pc:sldMk cId="2580895711" sldId="258"/>
            <ac:spMk id="12" creationId="{DD407F66-C418-48EA-9F90-83DA346B9F2D}"/>
          </ac:spMkLst>
        </pc:spChg>
        <pc:spChg chg="add mod">
          <ac:chgData name="Sarah Hill" userId="b774f213905f0ee8" providerId="LiveId" clId="{A784A022-F4FC-466A-B965-DECF04915295}" dt="2021-03-25T12:38:00.881" v="508" actId="1036"/>
          <ac:spMkLst>
            <pc:docMk/>
            <pc:sldMk cId="2580895711" sldId="258"/>
            <ac:spMk id="13" creationId="{8A676CF8-383E-4994-B8A1-37FA0D4CE12F}"/>
          </ac:spMkLst>
        </pc:spChg>
        <pc:spChg chg="add mod">
          <ac:chgData name="Sarah Hill" userId="b774f213905f0ee8" providerId="LiveId" clId="{A784A022-F4FC-466A-B965-DECF04915295}" dt="2021-03-25T12:38:19.495" v="534" actId="20577"/>
          <ac:spMkLst>
            <pc:docMk/>
            <pc:sldMk cId="2580895711" sldId="258"/>
            <ac:spMk id="14" creationId="{F1264A26-E4C2-49FB-A475-55FC8F7F3070}"/>
          </ac:spMkLst>
        </pc:spChg>
        <pc:spChg chg="add mod">
          <ac:chgData name="Sarah Hill" userId="b774f213905f0ee8" providerId="LiveId" clId="{A784A022-F4FC-466A-B965-DECF04915295}" dt="2021-03-25T12:38:35.959" v="557" actId="20577"/>
          <ac:spMkLst>
            <pc:docMk/>
            <pc:sldMk cId="2580895711" sldId="258"/>
            <ac:spMk id="15" creationId="{FF25BE7A-FB57-4BC0-8BDE-A7291D78E413}"/>
          </ac:spMkLst>
        </pc:spChg>
        <pc:picChg chg="add mod modCrop">
          <ac:chgData name="Sarah Hill" userId="b774f213905f0ee8" providerId="LiveId" clId="{A784A022-F4FC-466A-B965-DECF04915295}" dt="2021-03-25T12:30:04.664" v="73" actId="1076"/>
          <ac:picMkLst>
            <pc:docMk/>
            <pc:sldMk cId="2580895711" sldId="258"/>
            <ac:picMk id="3" creationId="{008D33F6-BF95-4B7E-BE2C-A41EB339BFF6}"/>
          </ac:picMkLst>
        </pc:picChg>
        <pc:picChg chg="add mod modCrop">
          <ac:chgData name="Sarah Hill" userId="b774f213905f0ee8" providerId="LiveId" clId="{A784A022-F4FC-466A-B965-DECF04915295}" dt="2021-03-25T12:38:24.866" v="537" actId="1076"/>
          <ac:picMkLst>
            <pc:docMk/>
            <pc:sldMk cId="2580895711" sldId="258"/>
            <ac:picMk id="5" creationId="{C1C0653D-EF99-495B-9F61-20CD14CA2195}"/>
          </ac:picMkLst>
        </pc:picChg>
      </pc:sldChg>
      <pc:sldChg chg="addSp delSp modSp new mod">
        <pc:chgData name="Sarah Hill" userId="b774f213905f0ee8" providerId="LiveId" clId="{A784A022-F4FC-466A-B965-DECF04915295}" dt="2021-03-25T12:36:56.753" v="382" actId="20577"/>
        <pc:sldMkLst>
          <pc:docMk/>
          <pc:sldMk cId="3891432" sldId="259"/>
        </pc:sldMkLst>
        <pc:spChg chg="add mod">
          <ac:chgData name="Sarah Hill" userId="b774f213905f0ee8" providerId="LiveId" clId="{A784A022-F4FC-466A-B965-DECF04915295}" dt="2021-03-25T12:36:09.277" v="305" actId="14100"/>
          <ac:spMkLst>
            <pc:docMk/>
            <pc:sldMk cId="3891432" sldId="259"/>
            <ac:spMk id="4" creationId="{5FFBC9C3-8BA3-4D01-B9C6-2E4FB0ED8CD1}"/>
          </ac:spMkLst>
        </pc:spChg>
        <pc:spChg chg="add del mod">
          <ac:chgData name="Sarah Hill" userId="b774f213905f0ee8" providerId="LiveId" clId="{A784A022-F4FC-466A-B965-DECF04915295}" dt="2021-03-25T12:34:25.699" v="224" actId="478"/>
          <ac:spMkLst>
            <pc:docMk/>
            <pc:sldMk cId="3891432" sldId="259"/>
            <ac:spMk id="5" creationId="{451F90B7-8505-4A65-A3FA-3E98757D4301}"/>
          </ac:spMkLst>
        </pc:spChg>
        <pc:spChg chg="add mod">
          <ac:chgData name="Sarah Hill" userId="b774f213905f0ee8" providerId="LiveId" clId="{A784A022-F4FC-466A-B965-DECF04915295}" dt="2021-03-25T12:36:03.381" v="303" actId="14100"/>
          <ac:spMkLst>
            <pc:docMk/>
            <pc:sldMk cId="3891432" sldId="259"/>
            <ac:spMk id="6" creationId="{2B57A8C0-9437-4F5B-AA8F-A498801C4C6B}"/>
          </ac:spMkLst>
        </pc:spChg>
        <pc:spChg chg="add mod">
          <ac:chgData name="Sarah Hill" userId="b774f213905f0ee8" providerId="LiveId" clId="{A784A022-F4FC-466A-B965-DECF04915295}" dt="2021-03-25T12:36:14.289" v="306" actId="1076"/>
          <ac:spMkLst>
            <pc:docMk/>
            <pc:sldMk cId="3891432" sldId="259"/>
            <ac:spMk id="7" creationId="{15774C00-A614-4F44-B868-DE2430ABE1B6}"/>
          </ac:spMkLst>
        </pc:spChg>
        <pc:spChg chg="add mod">
          <ac:chgData name="Sarah Hill" userId="b774f213905f0ee8" providerId="LiveId" clId="{A784A022-F4FC-466A-B965-DECF04915295}" dt="2021-03-25T12:36:21.672" v="309" actId="1076"/>
          <ac:spMkLst>
            <pc:docMk/>
            <pc:sldMk cId="3891432" sldId="259"/>
            <ac:spMk id="8" creationId="{E415B3B3-5183-47DA-A14A-2160B060007B}"/>
          </ac:spMkLst>
        </pc:spChg>
        <pc:spChg chg="add mod">
          <ac:chgData name="Sarah Hill" userId="b774f213905f0ee8" providerId="LiveId" clId="{A784A022-F4FC-466A-B965-DECF04915295}" dt="2021-03-25T12:35:49.055" v="281" actId="1076"/>
          <ac:spMkLst>
            <pc:docMk/>
            <pc:sldMk cId="3891432" sldId="259"/>
            <ac:spMk id="9" creationId="{876499EB-A38C-4FA4-855C-BDA3152DC4B7}"/>
          </ac:spMkLst>
        </pc:spChg>
        <pc:spChg chg="add mod">
          <ac:chgData name="Sarah Hill" userId="b774f213905f0ee8" providerId="LiveId" clId="{A784A022-F4FC-466A-B965-DECF04915295}" dt="2021-03-25T12:36:34.353" v="311" actId="1076"/>
          <ac:spMkLst>
            <pc:docMk/>
            <pc:sldMk cId="3891432" sldId="259"/>
            <ac:spMk id="10" creationId="{3E563BEB-78ED-4C4B-A807-9F44E00B5161}"/>
          </ac:spMkLst>
        </pc:spChg>
        <pc:spChg chg="add mod">
          <ac:chgData name="Sarah Hill" userId="b774f213905f0ee8" providerId="LiveId" clId="{A784A022-F4FC-466A-B965-DECF04915295}" dt="2021-03-25T12:36:34.353" v="311" actId="1076"/>
          <ac:spMkLst>
            <pc:docMk/>
            <pc:sldMk cId="3891432" sldId="259"/>
            <ac:spMk id="11" creationId="{A5077E68-3C3E-4E47-8DFF-2AC2A72222EA}"/>
          </ac:spMkLst>
        </pc:spChg>
        <pc:spChg chg="add mod">
          <ac:chgData name="Sarah Hill" userId="b774f213905f0ee8" providerId="LiveId" clId="{A784A022-F4FC-466A-B965-DECF04915295}" dt="2021-03-25T12:36:34.353" v="311" actId="1076"/>
          <ac:spMkLst>
            <pc:docMk/>
            <pc:sldMk cId="3891432" sldId="259"/>
            <ac:spMk id="12" creationId="{053F9104-6E42-487E-8186-97C5332B0981}"/>
          </ac:spMkLst>
        </pc:spChg>
        <pc:spChg chg="add mod">
          <ac:chgData name="Sarah Hill" userId="b774f213905f0ee8" providerId="LiveId" clId="{A784A022-F4FC-466A-B965-DECF04915295}" dt="2021-03-25T12:36:43.961" v="360" actId="1038"/>
          <ac:spMkLst>
            <pc:docMk/>
            <pc:sldMk cId="3891432" sldId="259"/>
            <ac:spMk id="13" creationId="{7B012D5B-4650-4990-907D-3452E8914765}"/>
          </ac:spMkLst>
        </pc:spChg>
        <pc:spChg chg="add mod">
          <ac:chgData name="Sarah Hill" userId="b774f213905f0ee8" providerId="LiveId" clId="{A784A022-F4FC-466A-B965-DECF04915295}" dt="2021-03-25T12:36:56.753" v="382" actId="20577"/>
          <ac:spMkLst>
            <pc:docMk/>
            <pc:sldMk cId="3891432" sldId="259"/>
            <ac:spMk id="14" creationId="{87F7ED2A-AE70-4645-AE63-0ECDEA077505}"/>
          </ac:spMkLst>
        </pc:spChg>
        <pc:picChg chg="add mod">
          <ac:chgData name="Sarah Hill" userId="b774f213905f0ee8" providerId="LiveId" clId="{A784A022-F4FC-466A-B965-DECF04915295}" dt="2021-03-25T12:36:18.089" v="308" actId="1076"/>
          <ac:picMkLst>
            <pc:docMk/>
            <pc:sldMk cId="3891432" sldId="259"/>
            <ac:picMk id="3" creationId="{805B488D-3C43-47A1-A729-22F3D43C158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777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011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055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270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655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949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042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691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655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48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551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832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C27C29A-2405-449F-AA5F-D67B4EE9755F}"/>
              </a:ext>
            </a:extLst>
          </p:cNvPr>
          <p:cNvSpPr txBox="1"/>
          <p:nvPr/>
        </p:nvSpPr>
        <p:spPr>
          <a:xfrm>
            <a:off x="1090246" y="1981200"/>
            <a:ext cx="4794739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ane order for ARK1 sip21 blot Figure 3K</a:t>
            </a:r>
          </a:p>
          <a:p>
            <a:endParaRPr lang="en-US" dirty="0"/>
          </a:p>
          <a:p>
            <a:r>
              <a:rPr lang="en-US" dirty="0"/>
              <a:t>15-Not this figure</a:t>
            </a:r>
          </a:p>
          <a:p>
            <a:r>
              <a:rPr lang="en-US" dirty="0"/>
              <a:t>14-Not this figure</a:t>
            </a:r>
          </a:p>
          <a:p>
            <a:r>
              <a:rPr lang="en-US" dirty="0"/>
              <a:t>13-Not this figure</a:t>
            </a:r>
          </a:p>
          <a:p>
            <a:r>
              <a:rPr lang="en-US" dirty="0"/>
              <a:t>12-Not this figure</a:t>
            </a:r>
          </a:p>
          <a:p>
            <a:r>
              <a:rPr lang="en-US" dirty="0"/>
              <a:t>11 Not this figure</a:t>
            </a:r>
          </a:p>
          <a:p>
            <a:r>
              <a:rPr lang="en-US" dirty="0"/>
              <a:t>10 Not this figure</a:t>
            </a:r>
          </a:p>
          <a:p>
            <a:r>
              <a:rPr lang="en-US" dirty="0"/>
              <a:t>9 Ladder</a:t>
            </a:r>
          </a:p>
          <a:p>
            <a:r>
              <a:rPr lang="en-US" dirty="0"/>
              <a:t>8 Not this figure</a:t>
            </a:r>
          </a:p>
          <a:p>
            <a:r>
              <a:rPr lang="en-US" dirty="0"/>
              <a:t>7 Not this figure</a:t>
            </a:r>
          </a:p>
          <a:p>
            <a:r>
              <a:rPr lang="en-US" dirty="0"/>
              <a:t>6 Not this figure</a:t>
            </a:r>
          </a:p>
          <a:p>
            <a:r>
              <a:rPr lang="en-US" dirty="0"/>
              <a:t>5 Ladder</a:t>
            </a:r>
          </a:p>
          <a:p>
            <a:r>
              <a:rPr lang="en-US" dirty="0"/>
              <a:t>4 ARK1 sip21-4</a:t>
            </a:r>
          </a:p>
          <a:p>
            <a:r>
              <a:rPr lang="en-US" dirty="0"/>
              <a:t>3 ARK1 sip21-1</a:t>
            </a:r>
          </a:p>
          <a:p>
            <a:r>
              <a:rPr lang="en-US" dirty="0"/>
              <a:t>2 ARK1 </a:t>
            </a:r>
            <a:r>
              <a:rPr lang="en-US" dirty="0" err="1"/>
              <a:t>siCONTROL</a:t>
            </a:r>
            <a:endParaRPr lang="en-US" dirty="0"/>
          </a:p>
          <a:p>
            <a:r>
              <a:rPr lang="en-US" dirty="0"/>
              <a:t>1 Ladder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DCE6CD1-79F6-46F9-84C1-EA69A534E682}"/>
              </a:ext>
            </a:extLst>
          </p:cNvPr>
          <p:cNvSpPr txBox="1"/>
          <p:nvPr/>
        </p:nvSpPr>
        <p:spPr>
          <a:xfrm>
            <a:off x="586154" y="339969"/>
            <a:ext cx="58615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r all blots specific to the figure, we have placed a box around the full western of interest and placed the lane numbers below. It.</a:t>
            </a:r>
          </a:p>
        </p:txBody>
      </p:sp>
    </p:spTree>
    <p:extLst>
      <p:ext uri="{BB962C8B-B14F-4D97-AF65-F5344CB8AC3E}">
        <p14:creationId xmlns:p14="http://schemas.microsoft.com/office/powerpoint/2010/main" val="10813735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nature&#10;&#10;Description automatically generated">
            <a:extLst>
              <a:ext uri="{FF2B5EF4-FFF2-40B4-BE49-F238E27FC236}">
                <a16:creationId xmlns:a16="http://schemas.microsoft.com/office/drawing/2014/main" id="{805B488D-3C43-47A1-A729-22F3D43C15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42406"/>
            <a:ext cx="6857999" cy="825918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FFBC9C3-8BA3-4D01-B9C6-2E4FB0ED8CD1}"/>
              </a:ext>
            </a:extLst>
          </p:cNvPr>
          <p:cNvSpPr/>
          <p:nvPr/>
        </p:nvSpPr>
        <p:spPr>
          <a:xfrm>
            <a:off x="2098431" y="2485292"/>
            <a:ext cx="920262" cy="1470863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57A8C0-9437-4F5B-AA8F-A498801C4C6B}"/>
              </a:ext>
            </a:extLst>
          </p:cNvPr>
          <p:cNvSpPr txBox="1"/>
          <p:nvPr/>
        </p:nvSpPr>
        <p:spPr>
          <a:xfrm>
            <a:off x="1963615" y="91950"/>
            <a:ext cx="2420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21 light for ladd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774C00-A614-4F44-B868-DE2430ABE1B6}"/>
              </a:ext>
            </a:extLst>
          </p:cNvPr>
          <p:cNvSpPr txBox="1"/>
          <p:nvPr/>
        </p:nvSpPr>
        <p:spPr>
          <a:xfrm rot="16200000">
            <a:off x="1761421" y="3853958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415B3B3-5183-47DA-A14A-2160B060007B}"/>
              </a:ext>
            </a:extLst>
          </p:cNvPr>
          <p:cNvSpPr txBox="1"/>
          <p:nvPr/>
        </p:nvSpPr>
        <p:spPr>
          <a:xfrm rot="16200000">
            <a:off x="2284632" y="4053249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76499EB-A38C-4FA4-855C-BDA3152DC4B7}"/>
              </a:ext>
            </a:extLst>
          </p:cNvPr>
          <p:cNvSpPr txBox="1"/>
          <p:nvPr/>
        </p:nvSpPr>
        <p:spPr>
          <a:xfrm rot="16200000">
            <a:off x="2237706" y="2777957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-  2  -3  -4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E563BEB-78ED-4C4B-A807-9F44E00B5161}"/>
              </a:ext>
            </a:extLst>
          </p:cNvPr>
          <p:cNvSpPr/>
          <p:nvPr/>
        </p:nvSpPr>
        <p:spPr>
          <a:xfrm>
            <a:off x="2123467" y="6683988"/>
            <a:ext cx="920262" cy="1470863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5077E68-3C3E-4E47-8DFF-2AC2A72222EA}"/>
              </a:ext>
            </a:extLst>
          </p:cNvPr>
          <p:cNvSpPr txBox="1"/>
          <p:nvPr/>
        </p:nvSpPr>
        <p:spPr>
          <a:xfrm rot="16200000">
            <a:off x="1786457" y="8052654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53F9104-6E42-487E-8186-97C5332B0981}"/>
              </a:ext>
            </a:extLst>
          </p:cNvPr>
          <p:cNvSpPr txBox="1"/>
          <p:nvPr/>
        </p:nvSpPr>
        <p:spPr>
          <a:xfrm rot="16200000">
            <a:off x="2309668" y="8251945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B012D5B-4650-4990-907D-3452E8914765}"/>
              </a:ext>
            </a:extLst>
          </p:cNvPr>
          <p:cNvSpPr txBox="1"/>
          <p:nvPr/>
        </p:nvSpPr>
        <p:spPr>
          <a:xfrm rot="16200000">
            <a:off x="2391695" y="6953207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-  2  -3  -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7F7ED2A-AE70-4645-AE63-0ECDEA077505}"/>
              </a:ext>
            </a:extLst>
          </p:cNvPr>
          <p:cNvSpPr txBox="1"/>
          <p:nvPr/>
        </p:nvSpPr>
        <p:spPr>
          <a:xfrm>
            <a:off x="3060166" y="8439516"/>
            <a:ext cx="2420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21 used</a:t>
            </a:r>
          </a:p>
        </p:txBody>
      </p:sp>
    </p:spTree>
    <p:extLst>
      <p:ext uri="{BB962C8B-B14F-4D97-AF65-F5344CB8AC3E}">
        <p14:creationId xmlns:p14="http://schemas.microsoft.com/office/powerpoint/2010/main" val="38914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kitchen appliance&#10;&#10;Description automatically generated">
            <a:extLst>
              <a:ext uri="{FF2B5EF4-FFF2-40B4-BE49-F238E27FC236}">
                <a16:creationId xmlns:a16="http://schemas.microsoft.com/office/drawing/2014/main" id="{008D33F6-BF95-4B7E-BE2C-A41EB339BFF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510"/>
          <a:stretch/>
        </p:blipFill>
        <p:spPr>
          <a:xfrm>
            <a:off x="0" y="5799851"/>
            <a:ext cx="6858000" cy="3344149"/>
          </a:xfrm>
          <a:prstGeom prst="rect">
            <a:avLst/>
          </a:prstGeom>
        </p:spPr>
      </p:pic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C1C0653D-EF99-495B-9F61-20CD14CA219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8723"/>
          <a:stretch/>
        </p:blipFill>
        <p:spPr>
          <a:xfrm>
            <a:off x="11724" y="1415421"/>
            <a:ext cx="6858000" cy="4235103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5DA87678-9ECF-42A8-9F9B-51127A9F297C}"/>
              </a:ext>
            </a:extLst>
          </p:cNvPr>
          <p:cNvSpPr/>
          <p:nvPr/>
        </p:nvSpPr>
        <p:spPr>
          <a:xfrm>
            <a:off x="304799" y="3376241"/>
            <a:ext cx="920262" cy="1470863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62B11E1-2683-4C02-9FC5-ABC6519226AA}"/>
              </a:ext>
            </a:extLst>
          </p:cNvPr>
          <p:cNvSpPr txBox="1"/>
          <p:nvPr/>
        </p:nvSpPr>
        <p:spPr>
          <a:xfrm rot="16200000">
            <a:off x="59383" y="5198627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376A62-EDF2-4315-B22A-956B40958F81}"/>
              </a:ext>
            </a:extLst>
          </p:cNvPr>
          <p:cNvSpPr txBox="1"/>
          <p:nvPr/>
        </p:nvSpPr>
        <p:spPr>
          <a:xfrm rot="16200000">
            <a:off x="491000" y="4944198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F4D95DE-BFF2-49B0-849C-3768E10997ED}"/>
              </a:ext>
            </a:extLst>
          </p:cNvPr>
          <p:cNvSpPr txBox="1"/>
          <p:nvPr/>
        </p:nvSpPr>
        <p:spPr>
          <a:xfrm rot="16200000">
            <a:off x="-306197" y="3554800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-  2  -3  -4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FA59DBF-47CA-4EED-8404-1575B22792DE}"/>
              </a:ext>
            </a:extLst>
          </p:cNvPr>
          <p:cNvSpPr/>
          <p:nvPr/>
        </p:nvSpPr>
        <p:spPr>
          <a:xfrm>
            <a:off x="420633" y="7751354"/>
            <a:ext cx="920262" cy="890959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164B682-423C-4CE0-AC9B-8790EB48CD65}"/>
              </a:ext>
            </a:extLst>
          </p:cNvPr>
          <p:cNvSpPr txBox="1"/>
          <p:nvPr/>
        </p:nvSpPr>
        <p:spPr>
          <a:xfrm rot="16200000">
            <a:off x="-263057" y="6474834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D407F66-C418-48EA-9F90-83DA346B9F2D}"/>
              </a:ext>
            </a:extLst>
          </p:cNvPr>
          <p:cNvSpPr txBox="1"/>
          <p:nvPr/>
        </p:nvSpPr>
        <p:spPr>
          <a:xfrm rot="16200000">
            <a:off x="581798" y="6490571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A676CF8-383E-4994-B8A1-37FA0D4CE12F}"/>
              </a:ext>
            </a:extLst>
          </p:cNvPr>
          <p:cNvSpPr txBox="1"/>
          <p:nvPr/>
        </p:nvSpPr>
        <p:spPr>
          <a:xfrm rot="16200000">
            <a:off x="-190363" y="7883021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-  2  -3  -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1264A26-E4C2-49FB-A475-55FC8F7F3070}"/>
              </a:ext>
            </a:extLst>
          </p:cNvPr>
          <p:cNvSpPr txBox="1"/>
          <p:nvPr/>
        </p:nvSpPr>
        <p:spPr>
          <a:xfrm>
            <a:off x="192048" y="1092819"/>
            <a:ext cx="2420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 dark for ladde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25BE7A-FB57-4BC0-8BDE-A7291D78E413}"/>
              </a:ext>
            </a:extLst>
          </p:cNvPr>
          <p:cNvSpPr txBox="1"/>
          <p:nvPr/>
        </p:nvSpPr>
        <p:spPr>
          <a:xfrm>
            <a:off x="373755" y="8747845"/>
            <a:ext cx="2420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 used</a:t>
            </a:r>
          </a:p>
        </p:txBody>
      </p:sp>
    </p:spTree>
    <p:extLst>
      <p:ext uri="{BB962C8B-B14F-4D97-AF65-F5344CB8AC3E}">
        <p14:creationId xmlns:p14="http://schemas.microsoft.com/office/powerpoint/2010/main" val="2580895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7</Words>
  <Application>Microsoft Office PowerPoint</Application>
  <PresentationFormat>Letter Paper (8.5x11 in)</PresentationFormat>
  <Paragraphs>3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Hill</dc:creator>
  <cp:lastModifiedBy>Sarah Hill</cp:lastModifiedBy>
  <cp:revision>2</cp:revision>
  <dcterms:created xsi:type="dcterms:W3CDTF">2021-03-25T04:32:01Z</dcterms:created>
  <dcterms:modified xsi:type="dcterms:W3CDTF">2021-03-27T18:30:08Z</dcterms:modified>
</cp:coreProperties>
</file>